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1"/>
  </p:notesMasterIdLst>
  <p:sldIdLst>
    <p:sldId id="256" r:id="rId2"/>
    <p:sldId id="257" r:id="rId3"/>
    <p:sldId id="258" r:id="rId4"/>
    <p:sldId id="259" r:id="rId5"/>
    <p:sldId id="263" r:id="rId6"/>
    <p:sldId id="262" r:id="rId7"/>
    <p:sldId id="261" r:id="rId8"/>
    <p:sldId id="264" r:id="rId9"/>
    <p:sldId id="265" r:id="rId10"/>
    <p:sldId id="260" r:id="rId11"/>
    <p:sldId id="266" r:id="rId12"/>
    <p:sldId id="272" r:id="rId13"/>
    <p:sldId id="273" r:id="rId14"/>
    <p:sldId id="274" r:id="rId15"/>
    <p:sldId id="271" r:id="rId16"/>
    <p:sldId id="270" r:id="rId17"/>
    <p:sldId id="269" r:id="rId18"/>
    <p:sldId id="275" r:id="rId19"/>
    <p:sldId id="268" r:id="rId20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19" autoAdjust="0"/>
  </p:normalViewPr>
  <p:slideViewPr>
    <p:cSldViewPr snapToGrid="0">
      <p:cViewPr varScale="1">
        <p:scale>
          <a:sx n="70" d="100"/>
          <a:sy n="70" d="100"/>
        </p:scale>
        <p:origin x="86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EA52C8-A008-41AF-8F52-DB234339CF3E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4311A4-8C70-4CD5-8D31-9184F3D8D073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2788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4311A4-8C70-4CD5-8D31-9184F3D8D073}" type="slidenum">
              <a:rPr lang="pl-PL" smtClean="0"/>
              <a:t>2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806110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0E854A16-DC90-4E46-80F0-347E1DF2F9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9F2AE3E2-B242-4548-9055-78F0761681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3F3428B8-9B50-4579-B617-3224E445E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8E5086E5-3DB0-4234-8CEF-88A4854A8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F23AF08D-2950-4D8E-95C8-E01DB86E71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60992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8588EF4F-DC6B-423E-BD21-598C62724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46915B61-8276-40DE-99FA-C55CCB7E61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B232E01B-C51E-493C-A57C-B572A7DE0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9673C814-A78D-4B4E-9264-7342016A42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3F68D3FE-93FC-48C2-85C2-A01111530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09474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BC1E7DCC-6502-4FB3-9F95-111EE4B6DD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DD4940D5-C4AB-41BC-A9BF-651A8378EC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328E562B-1D70-4675-A008-780A522C1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728690FE-17A4-4D92-AE29-B9F7A3F76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547F9EBB-E308-42FB-9AE9-2716EEDC1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88551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9E3604E4-4D44-4A63-8102-C8838218E0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F4F1E0F7-6A73-40B1-A684-0FE1467B6E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8789883B-7110-4A37-B29E-59592A464D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4809B718-ADB1-4F10-A26B-9E3E08107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A7D22A14-4953-4564-9988-3D00F3D56C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68711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05A5861-7EB6-4BBA-9070-2B43AB2A4A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9614B6AB-F345-491A-8E8B-EE5762F23A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D010F722-5372-493F-A5A0-6A204FE38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B72BD6B6-AC4F-4FDA-9620-6C1A4EEFE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8971A769-6BEC-4939-8022-D08E6B007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32346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2B03166C-1539-4D81-94A6-DD28CD0161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65EE96F1-4107-4E62-9F61-54487EF994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F07F7993-4E01-4948-84C2-F0818E90FC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A34DD0DA-78E9-429B-914C-4BA766378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121D0D60-8C43-4FB7-BE3D-0265278AB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0555185A-033E-4C95-BD79-D1C06CF71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3194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CE831BE7-DB57-455F-804D-AFB7C7040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F302FD19-82C2-4183-BF94-D6BEFB1991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2CF9EA25-D47C-4147-AF33-F84E7A9423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4F140E85-895A-43F3-B022-C009974C73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6C7453EF-BC50-4206-B590-F5FD3D80D2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AE3FCC82-23DC-45AF-837A-CEDD12EAD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F3215374-7C2E-480E-AFCA-50CE34F50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EC8C1F89-E0CC-4B57-B53E-DD81B46B1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68484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60A08CB8-377F-43A1-AA15-054FA804D2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841DDB76-28E6-46EB-99FC-C940BBA5C3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9D516EC6-FD8B-4D09-96D3-400DF61FD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1A3E2FA5-0DC4-4005-9BF6-82EF0B23E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27413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A465F9A6-024E-4E36-8C8E-59030FEF3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7754F1B7-64DE-486D-8D20-3E6B4A3FF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31B0EDAB-9332-47BC-B3CE-C52E16A0D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10265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AB44DEF9-3F5A-48CA-A98E-1B61A0909E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8F26791F-4D32-4FB5-B992-B5C4076C74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34CD0AC3-4EEF-4C99-AC14-A409564DA2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20A87DAA-2EEA-42F4-A6AC-8F3559A86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63CD16CC-5451-4552-9B3F-98D4A09F6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F73E55AA-2078-4543-9DDF-74BBD25A3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70477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FFCDFDE-AD21-4A43-8BA4-FD19FF2BF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83E6CACF-43E8-471C-964D-A7CE7233F2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AAD1B386-DCE5-4E40-A2A2-C5FEB76B0C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D5F4F478-7549-4834-9F8C-26737BF3D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C749A7B8-7675-449F-887C-84D38A15A1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FC6BAEEA-F7D2-482B-8F03-DE35C7AF7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65270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99697587-F1D6-44D5-9227-FCB7C64D0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F2AA371E-36CE-4405-B113-C71714E5D1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579ED2AE-9A7C-4A1B-AB0D-651149854E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F6B41-51A8-4748-8899-0FA9462C2A03}" type="datetimeFigureOut">
              <a:rPr lang="pl-PL" smtClean="0"/>
              <a:t>02.09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2526E59F-35E4-4652-86B2-9BD2AE5184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4492709B-9381-48B5-8CB4-66D10C10D4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4B1C7-E446-4AC2-9219-201693EDC6A0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24327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F937A5A4-0B40-4543-870E-D08BF8ED59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757382" y="2743200"/>
            <a:ext cx="10834254" cy="2392218"/>
          </a:xfrm>
        </p:spPr>
        <p:txBody>
          <a:bodyPr/>
          <a:lstStyle/>
          <a:p>
            <a:pPr algn="l"/>
            <a:r>
              <a:rPr lang="pl-PL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kub Rech </a:t>
            </a:r>
            <a:r>
              <a:rPr lang="pl-PL" sz="18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</a:t>
            </a:r>
            <a:r>
              <a:rPr lang="pl-PL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, Dorota </a:t>
            </a:r>
            <a:r>
              <a:rPr lang="pl-PL" sz="18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Żelaszczyk</a:t>
            </a:r>
            <a:r>
              <a:rPr lang="pl-PL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8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pl-PL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Henryk Marona </a:t>
            </a:r>
            <a:r>
              <a:rPr lang="pl-PL" sz="1800" b="1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pl-PL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Ilona Anna </a:t>
            </a:r>
            <a:r>
              <a:rPr lang="pl-PL" sz="18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dnarek </a:t>
            </a:r>
            <a:r>
              <a:rPr lang="pl-PL" sz="18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*</a:t>
            </a:r>
            <a:br>
              <a:rPr lang="pl-PL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endParaRPr lang="pl-PL" dirty="0"/>
          </a:p>
        </p:txBody>
      </p:sp>
      <p:sp>
        <p:nvSpPr>
          <p:cNvPr id="9" name="pole tekstowe 8">
            <a:extLst>
              <a:ext uri="{FF2B5EF4-FFF2-40B4-BE49-F238E27FC236}">
                <a16:creationId xmlns:a16="http://schemas.microsoft.com/office/drawing/2014/main" id="{DBB9DE56-23A0-4ABB-AAB9-3C70206287AD}"/>
              </a:ext>
            </a:extLst>
          </p:cNvPr>
          <p:cNvSpPr txBox="1"/>
          <p:nvPr/>
        </p:nvSpPr>
        <p:spPr>
          <a:xfrm>
            <a:off x="1191491" y="4780433"/>
            <a:ext cx="9144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l-PL" sz="1200" baseline="30000" dirty="0"/>
              <a:t>1</a:t>
            </a:r>
            <a:r>
              <a:rPr lang="pl-PL" sz="1200" dirty="0"/>
              <a:t>Department of </a:t>
            </a:r>
            <a:r>
              <a:rPr lang="pl-PL" sz="1200" dirty="0" err="1"/>
              <a:t>Biotechnology</a:t>
            </a:r>
            <a:r>
              <a:rPr lang="pl-PL" sz="1200" dirty="0"/>
              <a:t> and </a:t>
            </a:r>
            <a:r>
              <a:rPr lang="pl-PL" sz="1200" dirty="0" err="1"/>
              <a:t>Genetic</a:t>
            </a:r>
            <a:r>
              <a:rPr lang="pl-PL" sz="1200" dirty="0"/>
              <a:t> Engineering, </a:t>
            </a:r>
            <a:r>
              <a:rPr lang="pl-PL" sz="1200" dirty="0" err="1"/>
              <a:t>Faculty</a:t>
            </a:r>
            <a:r>
              <a:rPr lang="pl-PL" sz="1200" dirty="0"/>
              <a:t> of Pharmaceutical </a:t>
            </a:r>
            <a:r>
              <a:rPr lang="pl-PL" sz="1200" dirty="0" err="1"/>
              <a:t>Sciences</a:t>
            </a:r>
            <a:r>
              <a:rPr lang="pl-PL" sz="1200" dirty="0"/>
              <a:t> in Sosnowiec,</a:t>
            </a:r>
          </a:p>
          <a:p>
            <a:r>
              <a:rPr lang="pl-PL" sz="1200" dirty="0" err="1"/>
              <a:t>Medical</a:t>
            </a:r>
            <a:r>
              <a:rPr lang="pl-PL" sz="1200" dirty="0"/>
              <a:t> University of Silesia, 40-055 Katowice, Poland; jrech@sum.edu.pl (J.R), ibednarek@sum.edu.pl (I.A.B.)</a:t>
            </a:r>
          </a:p>
          <a:p>
            <a:r>
              <a:rPr lang="pl-PL" sz="1200" baseline="30000" dirty="0"/>
              <a:t>2</a:t>
            </a:r>
            <a:r>
              <a:rPr lang="pl-PL" sz="1200" dirty="0"/>
              <a:t>Department of </a:t>
            </a:r>
            <a:r>
              <a:rPr lang="pl-PL" sz="1200" dirty="0" err="1"/>
              <a:t>Bioorganic</a:t>
            </a:r>
            <a:r>
              <a:rPr lang="pl-PL" sz="1200" dirty="0"/>
              <a:t> </a:t>
            </a:r>
            <a:r>
              <a:rPr lang="pl-PL" sz="1200" dirty="0" err="1"/>
              <a:t>Chemistry</a:t>
            </a:r>
            <a:r>
              <a:rPr lang="pl-PL" sz="1200" dirty="0"/>
              <a:t>, Chair of </a:t>
            </a:r>
            <a:r>
              <a:rPr lang="pl-PL" sz="1200" dirty="0" err="1"/>
              <a:t>Organic</a:t>
            </a:r>
            <a:r>
              <a:rPr lang="pl-PL" sz="1200" dirty="0"/>
              <a:t> </a:t>
            </a:r>
            <a:r>
              <a:rPr lang="pl-PL" sz="1200" dirty="0" err="1"/>
              <a:t>Chemistry</a:t>
            </a:r>
            <a:r>
              <a:rPr lang="pl-PL" sz="1200" dirty="0"/>
              <a:t>, </a:t>
            </a:r>
            <a:r>
              <a:rPr lang="pl-PL" sz="1200" dirty="0" err="1"/>
              <a:t>Faculty</a:t>
            </a:r>
            <a:r>
              <a:rPr lang="pl-PL" sz="1200" dirty="0"/>
              <a:t> of </a:t>
            </a:r>
            <a:r>
              <a:rPr lang="pl-PL" sz="1200" dirty="0" err="1"/>
              <a:t>Pharmacy</a:t>
            </a:r>
            <a:r>
              <a:rPr lang="pl-PL" sz="1200" dirty="0"/>
              <a:t>, </a:t>
            </a:r>
            <a:r>
              <a:rPr lang="pl-PL" sz="1200" dirty="0" err="1"/>
              <a:t>Jagiellonian</a:t>
            </a:r>
            <a:r>
              <a:rPr lang="pl-PL" sz="1200" dirty="0"/>
              <a:t> University </a:t>
            </a:r>
            <a:r>
              <a:rPr lang="pl-PL" sz="1200" dirty="0" err="1"/>
              <a:t>Medical</a:t>
            </a:r>
            <a:r>
              <a:rPr lang="pl-PL" sz="1200" dirty="0"/>
              <a:t> College, 30-688 </a:t>
            </a:r>
            <a:r>
              <a:rPr lang="pl-PL" sz="1200" dirty="0" err="1"/>
              <a:t>Krakow</a:t>
            </a:r>
            <a:r>
              <a:rPr lang="pl-PL" sz="1200" dirty="0"/>
              <a:t>, Poland; dorota.zelaszczyk@uj.edu.pl (D.Z.); agnieszka.gunia@uj.edu.pl (A.G-K.); </a:t>
            </a:r>
          </a:p>
          <a:p>
            <a:r>
              <a:rPr lang="pl-PL" sz="1200" dirty="0"/>
              <a:t>*</a:t>
            </a:r>
            <a:r>
              <a:rPr lang="pl-PL" sz="1200" dirty="0" err="1"/>
              <a:t>Correspondence</a:t>
            </a:r>
            <a:r>
              <a:rPr lang="pl-PL" sz="1200" dirty="0"/>
              <a:t>: jrech@sum.edu.pl</a:t>
            </a:r>
          </a:p>
        </p:txBody>
      </p:sp>
      <p:sp>
        <p:nvSpPr>
          <p:cNvPr id="5" name="pole tekstowe 4">
            <a:extLst>
              <a:ext uri="{FF2B5EF4-FFF2-40B4-BE49-F238E27FC236}">
                <a16:creationId xmlns:a16="http://schemas.microsoft.com/office/drawing/2014/main" id="{D2AFBB1E-348E-4124-92AA-F90A7F53B844}"/>
              </a:ext>
            </a:extLst>
          </p:cNvPr>
          <p:cNvSpPr txBox="1"/>
          <p:nvPr/>
        </p:nvSpPr>
        <p:spPr>
          <a:xfrm>
            <a:off x="757382" y="625351"/>
            <a:ext cx="1049533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200"/>
              </a:spcAft>
            </a:pPr>
            <a:r>
              <a:rPr lang="en-US" sz="2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ynergistic Effects of Novel Xanthone Derivatives and Mild Hyperthermia in Ovarian Cancer: Insights from Gene</a:t>
            </a:r>
            <a:r>
              <a:rPr lang="pl-PL" sz="2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pression and in Silico Analyses</a:t>
            </a:r>
          </a:p>
        </p:txBody>
      </p:sp>
    </p:spTree>
    <p:extLst>
      <p:ext uri="{BB962C8B-B14F-4D97-AF65-F5344CB8AC3E}">
        <p14:creationId xmlns:p14="http://schemas.microsoft.com/office/powerpoint/2010/main" val="16115018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4E9EBE55-D3CC-4B70-8806-BD39A02D71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7" name="Symbol zastępczy zawartości 6">
            <a:extLst>
              <a:ext uri="{FF2B5EF4-FFF2-40B4-BE49-F238E27FC236}">
                <a16:creationId xmlns:a16="http://schemas.microsoft.com/office/drawing/2014/main" id="{46D04128-F145-475F-86D2-224DF6B1148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4672" y="1794337"/>
            <a:ext cx="6452811" cy="2766350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81B903F0-38C0-4162-8573-3C448CB3A7AD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9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21G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(b) SK-OV-3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8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Obraz 8">
            <a:extLst>
              <a:ext uri="{FF2B5EF4-FFF2-40B4-BE49-F238E27FC236}">
                <a16:creationId xmlns:a16="http://schemas.microsoft.com/office/drawing/2014/main" id="{59FFC7EF-EF32-46CD-80C9-A0A4C98FFF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333625"/>
            <a:ext cx="4210050" cy="2190750"/>
          </a:xfrm>
          <a:prstGeom prst="rect">
            <a:avLst/>
          </a:prstGeom>
        </p:spPr>
      </p:pic>
      <p:sp>
        <p:nvSpPr>
          <p:cNvPr id="6" name="pole tekstowe 5">
            <a:extLst>
              <a:ext uri="{FF2B5EF4-FFF2-40B4-BE49-F238E27FC236}">
                <a16:creationId xmlns:a16="http://schemas.microsoft.com/office/drawing/2014/main" id="{98C8C856-E381-4C71-9659-17B3351B3A0D}"/>
              </a:ext>
            </a:extLst>
          </p:cNvPr>
          <p:cNvSpPr txBox="1"/>
          <p:nvPr/>
        </p:nvSpPr>
        <p:spPr>
          <a:xfrm>
            <a:off x="2716088" y="4664336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8" name="pole tekstowe 7">
            <a:extLst>
              <a:ext uri="{FF2B5EF4-FFF2-40B4-BE49-F238E27FC236}">
                <a16:creationId xmlns:a16="http://schemas.microsoft.com/office/drawing/2014/main" id="{3DC87205-3AF1-418A-9382-872CC6327BBB}"/>
              </a:ext>
            </a:extLst>
          </p:cNvPr>
          <p:cNvSpPr txBox="1"/>
          <p:nvPr/>
        </p:nvSpPr>
        <p:spPr>
          <a:xfrm>
            <a:off x="8688834" y="4664336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25125676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5AF9EF1E-A719-4479-9A19-5E3C94BB6E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0524D972-68AE-4593-A64C-4EE16A07E68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3484" y="1769078"/>
            <a:ext cx="5670316" cy="2747963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C96DEDF6-B2FB-432D-959F-7EF9ADA45C01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0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pl-PL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21G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b) SK-OV-3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8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Obraz 7">
            <a:extLst>
              <a:ext uri="{FF2B5EF4-FFF2-40B4-BE49-F238E27FC236}">
                <a16:creationId xmlns:a16="http://schemas.microsoft.com/office/drawing/2014/main" id="{55E5FD44-873B-4C0A-9C4D-FB8DB41B45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53563"/>
            <a:ext cx="5444286" cy="2463478"/>
          </a:xfrm>
          <a:prstGeom prst="rect">
            <a:avLst/>
          </a:prstGeom>
        </p:spPr>
      </p:pic>
      <p:sp>
        <p:nvSpPr>
          <p:cNvPr id="7" name="pole tekstowe 6">
            <a:extLst>
              <a:ext uri="{FF2B5EF4-FFF2-40B4-BE49-F238E27FC236}">
                <a16:creationId xmlns:a16="http://schemas.microsoft.com/office/drawing/2014/main" id="{F8763464-F61B-4645-A60D-00136D6B5F93}"/>
              </a:ext>
            </a:extLst>
          </p:cNvPr>
          <p:cNvSpPr txBox="1"/>
          <p:nvPr/>
        </p:nvSpPr>
        <p:spPr>
          <a:xfrm>
            <a:off x="2697426" y="4866325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9" name="pole tekstowe 8">
            <a:extLst>
              <a:ext uri="{FF2B5EF4-FFF2-40B4-BE49-F238E27FC236}">
                <a16:creationId xmlns:a16="http://schemas.microsoft.com/office/drawing/2014/main" id="{BEA35068-6785-4217-BC6B-6D69AE7A1409}"/>
              </a:ext>
            </a:extLst>
          </p:cNvPr>
          <p:cNvSpPr txBox="1"/>
          <p:nvPr/>
        </p:nvSpPr>
        <p:spPr>
          <a:xfrm>
            <a:off x="8670172" y="4866325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33603991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81FA5E2F-3920-4B0B-BDB5-A3ABA04D01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C7AB87C2-EE71-4BC7-A438-871A14B91AA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6487" y="2907641"/>
            <a:ext cx="6498785" cy="1695862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5F19B5B8-CCAA-4BA3-9AD9-03F107330ED4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1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K-OV-3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IS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wnregula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TOV-21G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638854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81FA5E2F-3920-4B0B-BDB5-A3ABA04D01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pole tekstowe 3">
            <a:extLst>
              <a:ext uri="{FF2B5EF4-FFF2-40B4-BE49-F238E27FC236}">
                <a16:creationId xmlns:a16="http://schemas.microsoft.com/office/drawing/2014/main" id="{5F19B5B8-CCAA-4BA3-9AD9-03F107330ED4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2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pl-PL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TOV21G 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IS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pl-PL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regula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SK-OV-3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Symbol zastępczy zawartości 7">
            <a:extLst>
              <a:ext uri="{FF2B5EF4-FFF2-40B4-BE49-F238E27FC236}">
                <a16:creationId xmlns:a16="http://schemas.microsoft.com/office/drawing/2014/main" id="{AF821B45-017C-489D-A809-1A17DB2EC7B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119" y="2439083"/>
            <a:ext cx="5322302" cy="2769524"/>
          </a:xfrm>
        </p:spPr>
      </p:pic>
    </p:spTree>
    <p:extLst>
      <p:ext uri="{BB962C8B-B14F-4D97-AF65-F5344CB8AC3E}">
        <p14:creationId xmlns:p14="http://schemas.microsoft.com/office/powerpoint/2010/main" val="409280959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893782BF-DCA5-422E-8778-6ED7554B0C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pole tekstowe 3">
            <a:extLst>
              <a:ext uri="{FF2B5EF4-FFF2-40B4-BE49-F238E27FC236}">
                <a16:creationId xmlns:a16="http://schemas.microsoft.com/office/drawing/2014/main" id="{42445B52-A479-4830-A658-6FC048AC27BE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3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TOV21G 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MAG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wnregula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SK-OV-3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Symbol zastępczy zawartości 8">
            <a:extLst>
              <a:ext uri="{FF2B5EF4-FFF2-40B4-BE49-F238E27FC236}">
                <a16:creationId xmlns:a16="http://schemas.microsoft.com/office/drawing/2014/main" id="{31BCF8FA-CCCC-4771-9B7B-5F7B5226F99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056" y="2639027"/>
            <a:ext cx="5020773" cy="2271843"/>
          </a:xfrm>
        </p:spPr>
      </p:pic>
    </p:spTree>
    <p:extLst>
      <p:ext uri="{BB962C8B-B14F-4D97-AF65-F5344CB8AC3E}">
        <p14:creationId xmlns:p14="http://schemas.microsoft.com/office/powerpoint/2010/main" val="258772830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893782BF-DCA5-422E-8778-6ED7554B0C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56F3F661-536A-46E9-B47C-2809E78F8E9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1595" y="2311762"/>
            <a:ext cx="6198604" cy="3003984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42445B52-A479-4830-A658-6FC048AC27BE}"/>
              </a:ext>
            </a:extLst>
          </p:cNvPr>
          <p:cNvSpPr txBox="1"/>
          <p:nvPr/>
        </p:nvSpPr>
        <p:spPr>
          <a:xfrm>
            <a:off x="-901700" y="6332937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4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pl-PL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21G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b) SK-OV-3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MAG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Obraz 7">
            <a:extLst>
              <a:ext uri="{FF2B5EF4-FFF2-40B4-BE49-F238E27FC236}">
                <a16:creationId xmlns:a16="http://schemas.microsoft.com/office/drawing/2014/main" id="{3B4D5FC1-DE0A-4EB1-AD2C-3E9F6FD5E8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2492" y="3150972"/>
            <a:ext cx="4184995" cy="1325564"/>
          </a:xfrm>
          <a:prstGeom prst="rect">
            <a:avLst/>
          </a:prstGeom>
        </p:spPr>
      </p:pic>
      <p:sp>
        <p:nvSpPr>
          <p:cNvPr id="7" name="pole tekstowe 6">
            <a:extLst>
              <a:ext uri="{FF2B5EF4-FFF2-40B4-BE49-F238E27FC236}">
                <a16:creationId xmlns:a16="http://schemas.microsoft.com/office/drawing/2014/main" id="{9D971395-43C8-4122-BA4C-F3772603B7A7}"/>
              </a:ext>
            </a:extLst>
          </p:cNvPr>
          <p:cNvSpPr txBox="1"/>
          <p:nvPr/>
        </p:nvSpPr>
        <p:spPr>
          <a:xfrm>
            <a:off x="2716088" y="5484396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9" name="pole tekstowe 8">
            <a:extLst>
              <a:ext uri="{FF2B5EF4-FFF2-40B4-BE49-F238E27FC236}">
                <a16:creationId xmlns:a16="http://schemas.microsoft.com/office/drawing/2014/main" id="{25CA9095-3109-4681-A2EF-9CA75E98BAD8}"/>
              </a:ext>
            </a:extLst>
          </p:cNvPr>
          <p:cNvSpPr txBox="1"/>
          <p:nvPr/>
        </p:nvSpPr>
        <p:spPr>
          <a:xfrm>
            <a:off x="8688834" y="5484396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44738633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6A52E2F4-4863-406C-B368-52EDF8FD35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47A7B54E-95E6-4D0B-B04A-EC621E616C5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901700" y="1449392"/>
            <a:ext cx="7923211" cy="3206188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28F5AEB4-7C42-4E63-8149-55D776F2E39A}"/>
              </a:ext>
            </a:extLst>
          </p:cNvPr>
          <p:cNvSpPr txBox="1"/>
          <p:nvPr/>
        </p:nvSpPr>
        <p:spPr>
          <a:xfrm>
            <a:off x="-901700" y="6323606"/>
            <a:ext cx="12258964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5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ING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s interaction pathway analysi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-21G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(b) SK-OV-3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7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Proteins were grouped into clusters, based on their molecular function. Dotted lines represents the edges between clusters.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Obraz 7">
            <a:extLst>
              <a:ext uri="{FF2B5EF4-FFF2-40B4-BE49-F238E27FC236}">
                <a16:creationId xmlns:a16="http://schemas.microsoft.com/office/drawing/2014/main" id="{B170FA3E-C160-490C-92EC-49C08858FEC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5082" y="1612111"/>
            <a:ext cx="7067308" cy="3580139"/>
          </a:xfrm>
          <a:prstGeom prst="rect">
            <a:avLst/>
          </a:prstGeom>
        </p:spPr>
      </p:pic>
      <p:sp>
        <p:nvSpPr>
          <p:cNvPr id="7" name="pole tekstowe 6">
            <a:extLst>
              <a:ext uri="{FF2B5EF4-FFF2-40B4-BE49-F238E27FC236}">
                <a16:creationId xmlns:a16="http://schemas.microsoft.com/office/drawing/2014/main" id="{59EAC167-4C84-451A-8E57-DA5722D9B477}"/>
              </a:ext>
            </a:extLst>
          </p:cNvPr>
          <p:cNvSpPr txBox="1"/>
          <p:nvPr/>
        </p:nvSpPr>
        <p:spPr>
          <a:xfrm>
            <a:off x="2716088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9" name="pole tekstowe 8">
            <a:extLst>
              <a:ext uri="{FF2B5EF4-FFF2-40B4-BE49-F238E27FC236}">
                <a16:creationId xmlns:a16="http://schemas.microsoft.com/office/drawing/2014/main" id="{23789E29-E834-4B64-8655-4636910F7A86}"/>
              </a:ext>
            </a:extLst>
          </p:cNvPr>
          <p:cNvSpPr txBox="1"/>
          <p:nvPr/>
        </p:nvSpPr>
        <p:spPr>
          <a:xfrm>
            <a:off x="8688834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35642627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32D2C1E3-C480-4539-A87A-F8783E35B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42DEFE84-DD84-46E4-AB98-29CF7C8EDE3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782" y="2621404"/>
            <a:ext cx="4402083" cy="2229996"/>
          </a:xfrm>
        </p:spPr>
      </p:pic>
      <p:sp>
        <p:nvSpPr>
          <p:cNvPr id="9" name="pole tekstowe 8">
            <a:extLst>
              <a:ext uri="{FF2B5EF4-FFF2-40B4-BE49-F238E27FC236}">
                <a16:creationId xmlns:a16="http://schemas.microsoft.com/office/drawing/2014/main" id="{914DC105-E562-4849-8CF5-3CBA21E7DC2A}"/>
              </a:ext>
            </a:extLst>
          </p:cNvPr>
          <p:cNvSpPr txBox="1"/>
          <p:nvPr/>
        </p:nvSpPr>
        <p:spPr>
          <a:xfrm>
            <a:off x="-901700" y="6323606"/>
            <a:ext cx="12258964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6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ING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s interaction pathway analysi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-21G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(b) SK-OV-3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8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Proteins were grouped into clusters, based on their molecular function. Dotted lines represents the edges between clusters.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Obraz 10">
            <a:extLst>
              <a:ext uri="{FF2B5EF4-FFF2-40B4-BE49-F238E27FC236}">
                <a16:creationId xmlns:a16="http://schemas.microsoft.com/office/drawing/2014/main" id="{7CDC03EE-06E9-487F-9355-FE56412EAE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9834" y="251254"/>
            <a:ext cx="5295563" cy="5539992"/>
          </a:xfrm>
          <a:prstGeom prst="rect">
            <a:avLst/>
          </a:prstGeom>
        </p:spPr>
      </p:pic>
      <p:sp>
        <p:nvSpPr>
          <p:cNvPr id="7" name="pole tekstowe 6">
            <a:extLst>
              <a:ext uri="{FF2B5EF4-FFF2-40B4-BE49-F238E27FC236}">
                <a16:creationId xmlns:a16="http://schemas.microsoft.com/office/drawing/2014/main" id="{AB46601F-1F49-456B-A61E-364F77DE9D1E}"/>
              </a:ext>
            </a:extLst>
          </p:cNvPr>
          <p:cNvSpPr txBox="1"/>
          <p:nvPr/>
        </p:nvSpPr>
        <p:spPr>
          <a:xfrm>
            <a:off x="2716088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8" name="pole tekstowe 7">
            <a:extLst>
              <a:ext uri="{FF2B5EF4-FFF2-40B4-BE49-F238E27FC236}">
                <a16:creationId xmlns:a16="http://schemas.microsoft.com/office/drawing/2014/main" id="{92D971F2-194C-4CE5-80FF-1D566E00E7BD}"/>
              </a:ext>
            </a:extLst>
          </p:cNvPr>
          <p:cNvSpPr txBox="1"/>
          <p:nvPr/>
        </p:nvSpPr>
        <p:spPr>
          <a:xfrm>
            <a:off x="8688834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74674808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E4AE54D9-2475-4C71-916B-5E8F05EA49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02B4BCBF-361A-49D5-AEB2-3CE544B1AA8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46571" y="2366019"/>
            <a:ext cx="5559318" cy="2125961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BFF9B44C-2F67-44A5-B935-BC5FE92452DE}"/>
              </a:ext>
            </a:extLst>
          </p:cNvPr>
          <p:cNvSpPr txBox="1"/>
          <p:nvPr/>
        </p:nvSpPr>
        <p:spPr>
          <a:xfrm>
            <a:off x="-901700" y="6323606"/>
            <a:ext cx="12258964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7.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ING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s interaction pathway analysi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-21G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(b) SK-OV-3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ell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MAG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Proteins were grouped into clusters, based on their molecular function. Dotted lines represents the edges between clusters.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Obraz 7">
            <a:extLst>
              <a:ext uri="{FF2B5EF4-FFF2-40B4-BE49-F238E27FC236}">
                <a16:creationId xmlns:a16="http://schemas.microsoft.com/office/drawing/2014/main" id="{ED353B18-057C-4B50-8D68-5AC1C82678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0713" y="571588"/>
            <a:ext cx="6908696" cy="5406736"/>
          </a:xfrm>
          <a:prstGeom prst="rect">
            <a:avLst/>
          </a:prstGeom>
        </p:spPr>
      </p:pic>
      <p:sp>
        <p:nvSpPr>
          <p:cNvPr id="7" name="pole tekstowe 6">
            <a:extLst>
              <a:ext uri="{FF2B5EF4-FFF2-40B4-BE49-F238E27FC236}">
                <a16:creationId xmlns:a16="http://schemas.microsoft.com/office/drawing/2014/main" id="{BD920AE3-3D6D-4825-95EC-AD5008D7102A}"/>
              </a:ext>
            </a:extLst>
          </p:cNvPr>
          <p:cNvSpPr txBox="1"/>
          <p:nvPr/>
        </p:nvSpPr>
        <p:spPr>
          <a:xfrm>
            <a:off x="2716088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9" name="pole tekstowe 8">
            <a:extLst>
              <a:ext uri="{FF2B5EF4-FFF2-40B4-BE49-F238E27FC236}">
                <a16:creationId xmlns:a16="http://schemas.microsoft.com/office/drawing/2014/main" id="{F9A0DEBF-D156-431B-BA54-EAADEB9EE013}"/>
              </a:ext>
            </a:extLst>
          </p:cNvPr>
          <p:cNvSpPr txBox="1"/>
          <p:nvPr/>
        </p:nvSpPr>
        <p:spPr>
          <a:xfrm>
            <a:off x="8688834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42506771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9A3F94A6-C8FC-4230-A086-6225B06D77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FAD47900-C0D3-4282-B96E-537C752BF4C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344" y="1253331"/>
            <a:ext cx="5097718" cy="4351338"/>
          </a:xfrm>
        </p:spPr>
      </p:pic>
      <p:sp>
        <p:nvSpPr>
          <p:cNvPr id="8" name="pole tekstowe 7">
            <a:extLst>
              <a:ext uri="{FF2B5EF4-FFF2-40B4-BE49-F238E27FC236}">
                <a16:creationId xmlns:a16="http://schemas.microsoft.com/office/drawing/2014/main" id="{E4DA7B54-B531-42DA-9BC4-623795D83AEF}"/>
              </a:ext>
            </a:extLst>
          </p:cNvPr>
          <p:cNvSpPr txBox="1"/>
          <p:nvPr/>
        </p:nvSpPr>
        <p:spPr>
          <a:xfrm>
            <a:off x="-901700" y="6323606"/>
            <a:ext cx="12258964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8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ING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s interaction pathway analysis of TOV-21G cell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IS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YP7A1 was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wnregula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SK-OV-3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s were grouped into clusters, based on their molecular function. Dotted lines represents the edges between clusters.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29370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ole tekstowe 4">
            <a:extLst>
              <a:ext uri="{FF2B5EF4-FFF2-40B4-BE49-F238E27FC236}">
                <a16:creationId xmlns:a16="http://schemas.microsoft.com/office/drawing/2014/main" id="{9AEDEC27-A0FE-46A8-B38A-45968E057477}"/>
              </a:ext>
            </a:extLst>
          </p:cNvPr>
          <p:cNvSpPr txBox="1"/>
          <p:nvPr/>
        </p:nvSpPr>
        <p:spPr>
          <a:xfrm>
            <a:off x="-922759" y="6294049"/>
            <a:ext cx="12258964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network of interaction 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l-PL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21G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b) SK-OV-3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7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express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mmi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u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o to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umer to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ses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eraction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7" name="Obraz 6">
            <a:extLst>
              <a:ext uri="{FF2B5EF4-FFF2-40B4-BE49-F238E27FC236}">
                <a16:creationId xmlns:a16="http://schemas.microsoft.com/office/drawing/2014/main" id="{4A3063A8-BB22-439D-8354-FA842799E4E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256" y="212437"/>
            <a:ext cx="4956744" cy="5565284"/>
          </a:xfrm>
          <a:prstGeom prst="rect">
            <a:avLst/>
          </a:prstGeom>
        </p:spPr>
      </p:pic>
      <p:pic>
        <p:nvPicPr>
          <p:cNvPr id="17" name="Obraz 16">
            <a:extLst>
              <a:ext uri="{FF2B5EF4-FFF2-40B4-BE49-F238E27FC236}">
                <a16:creationId xmlns:a16="http://schemas.microsoft.com/office/drawing/2014/main" id="{765A60FE-4438-45D6-9690-05328BF5E4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1013" y="877930"/>
            <a:ext cx="4619185" cy="4014914"/>
          </a:xfrm>
          <a:prstGeom prst="rect">
            <a:avLst/>
          </a:prstGeom>
        </p:spPr>
      </p:pic>
      <p:sp>
        <p:nvSpPr>
          <p:cNvPr id="18" name="pole tekstowe 17">
            <a:extLst>
              <a:ext uri="{FF2B5EF4-FFF2-40B4-BE49-F238E27FC236}">
                <a16:creationId xmlns:a16="http://schemas.microsoft.com/office/drawing/2014/main" id="{25FC8C28-BE29-424E-93E4-451E5F5A479D}"/>
              </a:ext>
            </a:extLst>
          </p:cNvPr>
          <p:cNvSpPr txBox="1"/>
          <p:nvPr/>
        </p:nvSpPr>
        <p:spPr>
          <a:xfrm>
            <a:off x="2716088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19" name="pole tekstowe 18">
            <a:extLst>
              <a:ext uri="{FF2B5EF4-FFF2-40B4-BE49-F238E27FC236}">
                <a16:creationId xmlns:a16="http://schemas.microsoft.com/office/drawing/2014/main" id="{1FB3C7EC-D303-493C-91B6-672097E06493}"/>
              </a:ext>
            </a:extLst>
          </p:cNvPr>
          <p:cNvSpPr txBox="1"/>
          <p:nvPr/>
        </p:nvSpPr>
        <p:spPr>
          <a:xfrm>
            <a:off x="8688834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085694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27DBC3DA-BD58-453C-8C18-28B50857B0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pole tekstowe 4">
            <a:extLst>
              <a:ext uri="{FF2B5EF4-FFF2-40B4-BE49-F238E27FC236}">
                <a16:creationId xmlns:a16="http://schemas.microsoft.com/office/drawing/2014/main" id="{789AD500-B9EB-4FD2-84A1-E94DFFD13EF7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network of interaction 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l-PL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21G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b) SK-OV-3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8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Symbol zastępczy zawartości 10">
            <a:extLst>
              <a:ext uri="{FF2B5EF4-FFF2-40B4-BE49-F238E27FC236}">
                <a16:creationId xmlns:a16="http://schemas.microsoft.com/office/drawing/2014/main" id="{554DA47D-9B71-4361-8794-1FF8AE99ED7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31" y="69560"/>
            <a:ext cx="5296016" cy="5358760"/>
          </a:xfrm>
        </p:spPr>
      </p:pic>
      <p:pic>
        <p:nvPicPr>
          <p:cNvPr id="13" name="Obraz 12">
            <a:extLst>
              <a:ext uri="{FF2B5EF4-FFF2-40B4-BE49-F238E27FC236}">
                <a16:creationId xmlns:a16="http://schemas.microsoft.com/office/drawing/2014/main" id="{34249B97-96A2-4903-932D-905880AF66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6677" y="812391"/>
            <a:ext cx="5991253" cy="3936072"/>
          </a:xfrm>
          <a:prstGeom prst="rect">
            <a:avLst/>
          </a:prstGeom>
        </p:spPr>
      </p:pic>
      <p:sp>
        <p:nvSpPr>
          <p:cNvPr id="14" name="pole tekstowe 13">
            <a:extLst>
              <a:ext uri="{FF2B5EF4-FFF2-40B4-BE49-F238E27FC236}">
                <a16:creationId xmlns:a16="http://schemas.microsoft.com/office/drawing/2014/main" id="{3C6F8EEA-44E1-44D7-92C7-36EA46B4348C}"/>
              </a:ext>
            </a:extLst>
          </p:cNvPr>
          <p:cNvSpPr txBox="1"/>
          <p:nvPr/>
        </p:nvSpPr>
        <p:spPr>
          <a:xfrm>
            <a:off x="2716088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15" name="pole tekstowe 14">
            <a:extLst>
              <a:ext uri="{FF2B5EF4-FFF2-40B4-BE49-F238E27FC236}">
                <a16:creationId xmlns:a16="http://schemas.microsoft.com/office/drawing/2014/main" id="{DDF6A36D-9FB5-4CDB-AFE2-E6483B736C9D}"/>
              </a:ext>
            </a:extLst>
          </p:cNvPr>
          <p:cNvSpPr txBox="1"/>
          <p:nvPr/>
        </p:nvSpPr>
        <p:spPr>
          <a:xfrm>
            <a:off x="8688834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7170979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C673DAB7-EE3F-47EF-AC08-C7D5B08AFB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AB6DB586-FB51-45B5-9701-E607EAED4AD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40" y="1188315"/>
            <a:ext cx="5737737" cy="3846672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2FB6164E-8853-47B1-BAF2-31B49DD6E9C0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network of interaction of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l-PL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21G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b) SK-OV-3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8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Obraz 7">
            <a:extLst>
              <a:ext uri="{FF2B5EF4-FFF2-40B4-BE49-F238E27FC236}">
                <a16:creationId xmlns:a16="http://schemas.microsoft.com/office/drawing/2014/main" id="{AA172465-ACC8-41AC-BA94-394D674EF2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9311" y="493242"/>
            <a:ext cx="5787827" cy="4972130"/>
          </a:xfrm>
          <a:prstGeom prst="rect">
            <a:avLst/>
          </a:prstGeom>
        </p:spPr>
      </p:pic>
      <p:sp>
        <p:nvSpPr>
          <p:cNvPr id="9" name="pole tekstowe 8">
            <a:extLst>
              <a:ext uri="{FF2B5EF4-FFF2-40B4-BE49-F238E27FC236}">
                <a16:creationId xmlns:a16="http://schemas.microsoft.com/office/drawing/2014/main" id="{162D70D6-4811-4071-971C-C8FB26C57DB8}"/>
              </a:ext>
            </a:extLst>
          </p:cNvPr>
          <p:cNvSpPr txBox="1"/>
          <p:nvPr/>
        </p:nvSpPr>
        <p:spPr>
          <a:xfrm>
            <a:off x="2716088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10" name="pole tekstowe 9">
            <a:extLst>
              <a:ext uri="{FF2B5EF4-FFF2-40B4-BE49-F238E27FC236}">
                <a16:creationId xmlns:a16="http://schemas.microsoft.com/office/drawing/2014/main" id="{5E9D02AE-0E44-4F1C-A0B7-CF864E08BBEA}"/>
              </a:ext>
            </a:extLst>
          </p:cNvPr>
          <p:cNvSpPr txBox="1"/>
          <p:nvPr/>
        </p:nvSpPr>
        <p:spPr>
          <a:xfrm>
            <a:off x="8688834" y="581102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33939904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37A354E-049C-4A4C-A96A-D98201658E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E549C26E-0FCC-4562-B806-6B8F75DB3B6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747" y="439770"/>
            <a:ext cx="4772585" cy="5773534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7C6417E8-7BFD-4DD3-A7A7-70579DFBC5D7}"/>
              </a:ext>
            </a:extLst>
          </p:cNvPr>
          <p:cNvSpPr txBox="1"/>
          <p:nvPr/>
        </p:nvSpPr>
        <p:spPr>
          <a:xfrm>
            <a:off x="-901700" y="6323606"/>
            <a:ext cx="12258964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network of interaction of </a:t>
            </a:r>
            <a:r>
              <a:rPr lang="pl-PL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TOV21G 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IS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wnregula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mmi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u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ck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icantly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ng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SK-OV-3 and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YP7A1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regula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s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TOV-21G.</a:t>
            </a:r>
          </a:p>
        </p:txBody>
      </p:sp>
    </p:spTree>
    <p:extLst>
      <p:ext uri="{BB962C8B-B14F-4D97-AF65-F5344CB8AC3E}">
        <p14:creationId xmlns:p14="http://schemas.microsoft.com/office/powerpoint/2010/main" val="22591818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4B8C40F0-692E-46FF-9ED6-CCD6955DFD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B6A73FB1-1B98-403D-9883-F126C587597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0670" y="1403802"/>
            <a:ext cx="5169446" cy="4351338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63C07CD6-AA18-4EA0-A33F-76AF1D27368A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network of interaction 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</a:t>
            </a:r>
            <a:r>
              <a:rPr lang="pl-PL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21G 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MAG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icantly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wnregula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SK-OV-3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95081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E7DECD99-5798-429B-875B-06733506B4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pole tekstowe 3">
            <a:extLst>
              <a:ext uri="{FF2B5EF4-FFF2-40B4-BE49-F238E27FC236}">
                <a16:creationId xmlns:a16="http://schemas.microsoft.com/office/drawing/2014/main" id="{86B43285-5C96-4E12-9521-535554ABBC89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network of interaction 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K-OV-3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MAG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NAJC8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gnificantly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regula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TOV-21G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Obraz 7">
            <a:extLst>
              <a:ext uri="{FF2B5EF4-FFF2-40B4-BE49-F238E27FC236}">
                <a16:creationId xmlns:a16="http://schemas.microsoft.com/office/drawing/2014/main" id="{53340A76-595E-40CF-A770-2DC9CC6405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5235" y="365125"/>
            <a:ext cx="5994755" cy="56996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17268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5D64AD1-3542-455F-8915-8E8C10A96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E4B0A277-26BA-4928-BFAC-0135764F4BA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7911" y="3035847"/>
            <a:ext cx="5516178" cy="1439450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3E20EE06-9CE5-4EFA-B418-135E8461FF15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7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K-OV-3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treatment.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wnregula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ed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TOV-21G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0628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6D437A6-1615-4A56-BC04-9F94555BE4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6" name="Symbol zastępczy zawartości 5">
            <a:extLst>
              <a:ext uri="{FF2B5EF4-FFF2-40B4-BE49-F238E27FC236}">
                <a16:creationId xmlns:a16="http://schemas.microsoft.com/office/drawing/2014/main" id="{5679B89C-3BE9-447E-9EB8-9DB0A6ABD63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7319" y="2604303"/>
            <a:ext cx="5756481" cy="1824048"/>
          </a:xfr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1A34705C-2C18-4830-848A-6245C34ED2A0}"/>
              </a:ext>
            </a:extLst>
          </p:cNvPr>
          <p:cNvSpPr txBox="1"/>
          <p:nvPr/>
        </p:nvSpPr>
        <p:spPr>
          <a:xfrm>
            <a:off x="-901700" y="6323606"/>
            <a:ext cx="12258964" cy="2239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l-PL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r>
              <a:rPr lang="en-US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derex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sed genes of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V21G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(b) SK-OV-3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9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ultaneous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 </a:t>
            </a:r>
            <a:r>
              <a:rPr lang="pl-PL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C7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eatment. </a:t>
            </a:r>
            <a:endParaRPr lang="pl-PL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Obraz 7">
            <a:extLst>
              <a:ext uri="{FF2B5EF4-FFF2-40B4-BE49-F238E27FC236}">
                <a16:creationId xmlns:a16="http://schemas.microsoft.com/office/drawing/2014/main" id="{02CCE8CF-392A-48A3-96D6-778A775DE16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3043" y="2490568"/>
            <a:ext cx="4210050" cy="2190750"/>
          </a:xfrm>
          <a:prstGeom prst="rect">
            <a:avLst/>
          </a:prstGeom>
        </p:spPr>
      </p:pic>
      <p:sp>
        <p:nvSpPr>
          <p:cNvPr id="7" name="pole tekstowe 6">
            <a:extLst>
              <a:ext uri="{FF2B5EF4-FFF2-40B4-BE49-F238E27FC236}">
                <a16:creationId xmlns:a16="http://schemas.microsoft.com/office/drawing/2014/main" id="{7FB31B85-AB10-49CB-A12E-9DADF7EA90EF}"/>
              </a:ext>
            </a:extLst>
          </p:cNvPr>
          <p:cNvSpPr txBox="1"/>
          <p:nvPr/>
        </p:nvSpPr>
        <p:spPr>
          <a:xfrm>
            <a:off x="2753410" y="482198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a)</a:t>
            </a:r>
          </a:p>
        </p:txBody>
      </p:sp>
      <p:sp>
        <p:nvSpPr>
          <p:cNvPr id="9" name="pole tekstowe 8">
            <a:extLst>
              <a:ext uri="{FF2B5EF4-FFF2-40B4-BE49-F238E27FC236}">
                <a16:creationId xmlns:a16="http://schemas.microsoft.com/office/drawing/2014/main" id="{17128DC7-DF3C-42A8-8AF3-E2BC9B1FFAF3}"/>
              </a:ext>
            </a:extLst>
          </p:cNvPr>
          <p:cNvSpPr txBox="1"/>
          <p:nvPr/>
        </p:nvSpPr>
        <p:spPr>
          <a:xfrm>
            <a:off x="8726156" y="4821980"/>
            <a:ext cx="3935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>
                <a:latin typeface="Palatino Linotype" panose="0204050205050503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611044487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</TotalTime>
  <Words>796</Words>
  <Application>Microsoft Office PowerPoint</Application>
  <PresentationFormat>Panoramiczny</PresentationFormat>
  <Paragraphs>45</Paragraphs>
  <Slides>19</Slides>
  <Notes>1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9</vt:i4>
      </vt:variant>
    </vt:vector>
  </HeadingPairs>
  <TitlesOfParts>
    <vt:vector size="24" baseType="lpstr">
      <vt:lpstr>Arial</vt:lpstr>
      <vt:lpstr>Calibri</vt:lpstr>
      <vt:lpstr>Calibri Light</vt:lpstr>
      <vt:lpstr>Palatino Linotype</vt:lpstr>
      <vt:lpstr>Motyw pakietu Office</vt:lpstr>
      <vt:lpstr>Jakub Rech 1,*, Dorota Żelaszczyk 2, Henryk Marona 2, and Ilona Anna Bednarek 1,* 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Jakub Rech 1,*, Dorota Żelaszczyk 2, Henryk Marona 2, Agnieszka Gunia-Krzyżak 2, Paweł Żmudzki 3 and Ilona Anna Bednarek 1</dc:title>
  <dc:creator>Jakub</dc:creator>
  <cp:lastModifiedBy>Jakub Rech</cp:lastModifiedBy>
  <cp:revision>25</cp:revision>
  <dcterms:created xsi:type="dcterms:W3CDTF">2024-10-04T09:00:07Z</dcterms:created>
  <dcterms:modified xsi:type="dcterms:W3CDTF">2025-09-02T11:23:12Z</dcterms:modified>
</cp:coreProperties>
</file>